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handoutMasterIdLst>
    <p:handoutMasterId r:id="rId5"/>
  </p:handoutMasterIdLst>
  <p:sldIdLst>
    <p:sldId id="364" r:id="rId2"/>
    <p:sldId id="362" r:id="rId3"/>
  </p:sldIdLst>
  <p:sldSz cx="6119813" cy="8099425"/>
  <p:notesSz cx="9866313" cy="67357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51">
          <p15:clr>
            <a:srgbClr val="A4A3A4"/>
          </p15:clr>
        </p15:guide>
        <p15:guide id="2" pos="192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0000"/>
    <a:srgbClr val="F7F7F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00E9E71-0B0E-414D-A9F4-57C8BEECBFD5}" v="2" dt="2022-05-06T00:28:34.93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740" autoAdjust="0"/>
    <p:restoredTop sz="92025" autoAdjust="0"/>
  </p:normalViewPr>
  <p:slideViewPr>
    <p:cSldViewPr snapToGrid="0">
      <p:cViewPr varScale="1">
        <p:scale>
          <a:sx n="123" d="100"/>
          <a:sy n="123" d="100"/>
        </p:scale>
        <p:origin x="2346" y="90"/>
      </p:cViewPr>
      <p:guideLst>
        <p:guide orient="horz" pos="2551"/>
        <p:guide pos="1927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4276255" cy="33705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587733" y="1"/>
            <a:ext cx="4276254" cy="33705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8F7887-721D-43D3-9B80-934D52076739}" type="datetimeFigureOut">
              <a:rPr kumimoji="1" lang="ja-JP" altLang="en-US" smtClean="0"/>
              <a:t>2025/2/1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1" y="6397620"/>
            <a:ext cx="4276255" cy="33705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587733" y="6397620"/>
            <a:ext cx="4276254" cy="33705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2A0700-AF77-43FB-9268-FE61CA17F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25405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275403" cy="3379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588627" y="0"/>
            <a:ext cx="4275403" cy="3379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4FF5EE-FE4B-472B-A9C8-232ED5865A06}" type="datetimeFigureOut">
              <a:rPr kumimoji="1" lang="ja-JP" altLang="en-US" smtClean="0"/>
              <a:t>2025/2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75113" y="841375"/>
            <a:ext cx="1716087" cy="22733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86632" y="3241586"/>
            <a:ext cx="7893050" cy="265220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6397807"/>
            <a:ext cx="4275403" cy="337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588627" y="6397807"/>
            <a:ext cx="4275403" cy="337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A36F8E-1B9E-40DF-82A7-D0F76A94A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93462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A.SC7-2 B  C NC6-2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DA36F8E-1B9E-40DF-82A7-D0F76A94A9FC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37930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325531"/>
            <a:ext cx="5201841" cy="2819800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254073"/>
            <a:ext cx="4589860" cy="1955486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989E6-9A7C-4E99-861C-E41D60177B8D}" type="datetimeFigureOut">
              <a:rPr kumimoji="1" lang="ja-JP" altLang="en-US" smtClean="0"/>
              <a:t>2025/2/19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5632C-4312-4B42-8168-B8CB5562F0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1453679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989E6-9A7C-4E99-861C-E41D60177B8D}" type="datetimeFigureOut">
              <a:rPr kumimoji="1" lang="ja-JP" altLang="en-US" smtClean="0"/>
              <a:t>2025/2/19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5632C-4312-4B42-8168-B8CB5562F0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833362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31220"/>
            <a:ext cx="1319585" cy="686388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31220"/>
            <a:ext cx="3882256" cy="686388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989E6-9A7C-4E99-861C-E41D60177B8D}" type="datetimeFigureOut">
              <a:rPr kumimoji="1" lang="ja-JP" altLang="en-US" smtClean="0"/>
              <a:t>2025/2/19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5632C-4312-4B42-8168-B8CB5562F0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5062995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989E6-9A7C-4E99-861C-E41D60177B8D}" type="datetimeFigureOut">
              <a:rPr kumimoji="1" lang="ja-JP" altLang="en-US" smtClean="0"/>
              <a:t>2025/2/19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5632C-4312-4B42-8168-B8CB5562F0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9018172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019234"/>
            <a:ext cx="5278339" cy="3369135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420242"/>
            <a:ext cx="5278339" cy="1771749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989E6-9A7C-4E99-861C-E41D60177B8D}" type="datetimeFigureOut">
              <a:rPr kumimoji="1" lang="ja-JP" altLang="en-US" smtClean="0"/>
              <a:t>2025/2/19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5632C-4312-4B42-8168-B8CB5562F0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1695764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156097"/>
            <a:ext cx="2600921" cy="513901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156097"/>
            <a:ext cx="2600921" cy="513901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989E6-9A7C-4E99-861C-E41D60177B8D}" type="datetimeFigureOut">
              <a:rPr kumimoji="1" lang="ja-JP" altLang="en-US" smtClean="0"/>
              <a:t>2025/2/19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5632C-4312-4B42-8168-B8CB5562F0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8892269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31221"/>
            <a:ext cx="5278339" cy="156551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985485"/>
            <a:ext cx="2588967" cy="973055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958540"/>
            <a:ext cx="2588967" cy="435156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985485"/>
            <a:ext cx="2601718" cy="973055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958540"/>
            <a:ext cx="2601718" cy="435156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989E6-9A7C-4E99-861C-E41D60177B8D}" type="datetimeFigureOut">
              <a:rPr kumimoji="1" lang="ja-JP" altLang="en-US" smtClean="0"/>
              <a:t>2025/2/19</a:t>
            </a:fld>
            <a:endParaRPr kumimoji="1" lang="ja-JP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5632C-4312-4B42-8168-B8CB5562F0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718133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989E6-9A7C-4E99-861C-E41D60177B8D}" type="datetimeFigureOut">
              <a:rPr kumimoji="1" lang="ja-JP" altLang="en-US" smtClean="0"/>
              <a:t>2025/2/19</a:t>
            </a:fld>
            <a:endParaRPr kumimoji="1" lang="ja-JP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5632C-4312-4B42-8168-B8CB5562F0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7103082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989E6-9A7C-4E99-861C-E41D60177B8D}" type="datetimeFigureOut">
              <a:rPr kumimoji="1" lang="ja-JP" altLang="en-US" smtClean="0"/>
              <a:t>2025/2/19</a:t>
            </a:fld>
            <a:endParaRPr kumimoji="1" lang="ja-JP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5632C-4312-4B42-8168-B8CB5562F0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9931969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39962"/>
            <a:ext cx="1973799" cy="188986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66169"/>
            <a:ext cx="3098155" cy="5755841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29828"/>
            <a:ext cx="1973799" cy="45015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989E6-9A7C-4E99-861C-E41D60177B8D}" type="datetimeFigureOut">
              <a:rPr kumimoji="1" lang="ja-JP" altLang="en-US" smtClean="0"/>
              <a:t>2025/2/19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5632C-4312-4B42-8168-B8CB5562F0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9529052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39962"/>
            <a:ext cx="1973799" cy="188986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66169"/>
            <a:ext cx="3098155" cy="5755841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ja-JP" altLang="en-US" dirty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29828"/>
            <a:ext cx="1973799" cy="45015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989E6-9A7C-4E99-861C-E41D60177B8D}" type="datetimeFigureOut">
              <a:rPr kumimoji="1" lang="ja-JP" altLang="en-US" smtClean="0"/>
              <a:t>2025/2/19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5632C-4312-4B42-8168-B8CB5562F0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1341629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31221"/>
            <a:ext cx="5278339" cy="156551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156097"/>
            <a:ext cx="5278339" cy="51390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506969"/>
            <a:ext cx="1376958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A989E6-9A7C-4E99-861C-E41D60177B8D}" type="datetimeFigureOut">
              <a:rPr kumimoji="1" lang="ja-JP" altLang="en-US" smtClean="0"/>
              <a:t>2025/2/19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506969"/>
            <a:ext cx="2065437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506969"/>
            <a:ext cx="1376958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A5632C-4312-4B42-8168-B8CB5562F0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677636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kumimoji="1"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kumimoji="1"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6.jpeg"/><Relationship Id="rId4" Type="http://schemas.openxmlformats.org/officeDocument/2006/relationships/image" Target="../media/image5.jpe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="" xmlns:a16="http://schemas.microsoft.com/office/drawing/2014/main" id="{BEE2D02A-970B-BAF1-E085-4FE62B7B8135}"/>
              </a:ext>
            </a:extLst>
          </p:cNvPr>
          <p:cNvSpPr txBox="1"/>
          <p:nvPr/>
        </p:nvSpPr>
        <p:spPr>
          <a:xfrm>
            <a:off x="3537055" y="10726"/>
            <a:ext cx="23647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="" xmlns:a16="http://schemas.microsoft.com/office/drawing/2014/main" id="{7568ACA3-4F36-7587-DD05-48CC33E759F6}"/>
              </a:ext>
            </a:extLst>
          </p:cNvPr>
          <p:cNvSpPr txBox="1"/>
          <p:nvPr/>
        </p:nvSpPr>
        <p:spPr>
          <a:xfrm>
            <a:off x="0" y="437495"/>
            <a:ext cx="18437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GTT 18w</a:t>
            </a:r>
            <a:r>
              <a: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="" xmlns:a16="http://schemas.microsoft.com/office/drawing/2014/main" id="{4446D234-63ED-2A23-4E31-11D79E6A1AD6}"/>
              </a:ext>
            </a:extLst>
          </p:cNvPr>
          <p:cNvSpPr txBox="1"/>
          <p:nvPr/>
        </p:nvSpPr>
        <p:spPr>
          <a:xfrm>
            <a:off x="103147" y="3311236"/>
            <a:ext cx="17956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kumimoji="1" lang="en-US" altLang="ja-JP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pITT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8w</a:t>
            </a:r>
            <a:r>
              <a: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="" xmlns:a16="http://schemas.microsoft.com/office/drawing/2014/main" id="{9399EB52-77C8-811F-E9AD-4E727E9A0133}"/>
              </a:ext>
            </a:extLst>
          </p:cNvPr>
          <p:cNvSpPr txBox="1"/>
          <p:nvPr/>
        </p:nvSpPr>
        <p:spPr>
          <a:xfrm>
            <a:off x="986562" y="759912"/>
            <a:ext cx="8402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(mg/</a:t>
            </a:r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dL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="" xmlns:a16="http://schemas.microsoft.com/office/drawing/2014/main" id="{9399EB52-77C8-811F-E9AD-4E727E9A0133}"/>
              </a:ext>
            </a:extLst>
          </p:cNvPr>
          <p:cNvSpPr txBox="1"/>
          <p:nvPr/>
        </p:nvSpPr>
        <p:spPr>
          <a:xfrm>
            <a:off x="4393845" y="3052814"/>
            <a:ext cx="6222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(min)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="" xmlns:a16="http://schemas.microsoft.com/office/drawing/2014/main" id="{9399EB52-77C8-811F-E9AD-4E727E9A0133}"/>
              </a:ext>
            </a:extLst>
          </p:cNvPr>
          <p:cNvSpPr txBox="1"/>
          <p:nvPr/>
        </p:nvSpPr>
        <p:spPr>
          <a:xfrm>
            <a:off x="4429417" y="5857149"/>
            <a:ext cx="6222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(min)</a:t>
            </a:r>
          </a:p>
        </p:txBody>
      </p:sp>
      <p:graphicFrame>
        <p:nvGraphicFramePr>
          <p:cNvPr id="18" name="オブジェクト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07124134"/>
              </p:ext>
            </p:extLst>
          </p:nvPr>
        </p:nvGraphicFramePr>
        <p:xfrm>
          <a:off x="884522" y="3705888"/>
          <a:ext cx="3856038" cy="2459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8" r:id="rId3" imgW="3855613" imgH="2459132" progId="Prism8.Document">
                  <p:embed/>
                </p:oleObj>
              </mc:Choice>
              <mc:Fallback>
                <p:oleObj name="Prism 8" r:id="rId3" imgW="3855613" imgH="2459132" progId="Prism8.Document">
                  <p:embed/>
                  <p:pic>
                    <p:nvPicPr>
                      <p:cNvPr id="7" name="オブジェクト 6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84522" y="3705888"/>
                        <a:ext cx="3856038" cy="24590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オブジェクト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2114845"/>
              </p:ext>
            </p:extLst>
          </p:nvPr>
        </p:nvGraphicFramePr>
        <p:xfrm>
          <a:off x="848950" y="952624"/>
          <a:ext cx="3856038" cy="2459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Prism 8" r:id="rId5" imgW="3855613" imgH="2459132" progId="Prism8.Document">
                  <p:embed/>
                </p:oleObj>
              </mc:Choice>
              <mc:Fallback>
                <p:oleObj name="Prism 8" r:id="rId5" imgW="3855613" imgH="245913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48950" y="952624"/>
                        <a:ext cx="3856038" cy="2459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" name="図 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28279" y="1625620"/>
            <a:ext cx="1133633" cy="971686"/>
          </a:xfrm>
          <a:prstGeom prst="rect">
            <a:avLst/>
          </a:prstGeom>
        </p:spPr>
      </p:pic>
      <p:pic>
        <p:nvPicPr>
          <p:cNvPr id="17" name="図 1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28278" y="4449564"/>
            <a:ext cx="1133633" cy="971686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="" xmlns:a16="http://schemas.microsoft.com/office/drawing/2014/main" id="{C895257A-BCCA-B894-0815-30FDE96D4B89}"/>
              </a:ext>
            </a:extLst>
          </p:cNvPr>
          <p:cNvSpPr txBox="1"/>
          <p:nvPr/>
        </p:nvSpPr>
        <p:spPr>
          <a:xfrm>
            <a:off x="0" y="6483449"/>
            <a:ext cx="6119813" cy="14441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: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The results of the OGTT at 18 weeks for the control,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saxerenone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spironolactone groups in the diabetic model.  There were no significant differences in glucose tolerance among the 3 groups (n = 4-6). (B) The results of the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pIT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 18 weeks for the control,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saxerenone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spironolactone groups in the diabetic model.  There were no significant differences in insulin sensitivity among the 3 groups (n = 4-6).</a:t>
            </a:r>
          </a:p>
        </p:txBody>
      </p:sp>
    </p:spTree>
    <p:extLst>
      <p:ext uri="{BB962C8B-B14F-4D97-AF65-F5344CB8AC3E}">
        <p14:creationId xmlns:p14="http://schemas.microsoft.com/office/powerpoint/2010/main" val="35158732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="" xmlns:a16="http://schemas.microsoft.com/office/drawing/2014/main" id="{53A4A4B7-3D21-9EA2-2980-A6F84768876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="" xmlns:a16="http://schemas.microsoft.com/office/drawing/2014/main" id="{4FC46D5D-40E8-A65D-EEB9-175CC9ECB37E}"/>
              </a:ext>
            </a:extLst>
          </p:cNvPr>
          <p:cNvSpPr txBox="1"/>
          <p:nvPr/>
        </p:nvSpPr>
        <p:spPr>
          <a:xfrm>
            <a:off x="1013055" y="351251"/>
            <a:ext cx="11961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-DM</a:t>
            </a:r>
            <a:r>
              <a:rPr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="" xmlns:a16="http://schemas.microsoft.com/office/drawing/2014/main" id="{38F1EEAC-FAC8-F5D8-8620-8AEC0E1BD61A}"/>
              </a:ext>
            </a:extLst>
          </p:cNvPr>
          <p:cNvSpPr txBox="1"/>
          <p:nvPr/>
        </p:nvSpPr>
        <p:spPr>
          <a:xfrm>
            <a:off x="4158842" y="2380371"/>
            <a:ext cx="7922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 </a:t>
            </a:r>
            <a:r>
              <a:rPr kumimoji="1" lang="en-US" altLang="ja-JP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i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="" xmlns:a16="http://schemas.microsoft.com/office/drawing/2014/main" id="{8CAD9D89-87AB-3607-E085-5A01CBDDB277}"/>
              </a:ext>
            </a:extLst>
          </p:cNvPr>
          <p:cNvSpPr txBox="1"/>
          <p:nvPr/>
        </p:nvSpPr>
        <p:spPr>
          <a:xfrm>
            <a:off x="164205" y="280562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="" xmlns:a16="http://schemas.microsoft.com/office/drawing/2014/main" id="{13EE2C32-3912-8E26-95F5-5A051A15C6E7}"/>
              </a:ext>
            </a:extLst>
          </p:cNvPr>
          <p:cNvSpPr txBox="1"/>
          <p:nvPr/>
        </p:nvSpPr>
        <p:spPr>
          <a:xfrm>
            <a:off x="3147175" y="302502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2" name="図 21">
            <a:extLst>
              <a:ext uri="{FF2B5EF4-FFF2-40B4-BE49-F238E27FC236}">
                <a16:creationId xmlns="" xmlns:a16="http://schemas.microsoft.com/office/drawing/2014/main" id="{8F1042C6-82AF-8B0F-722F-06478B8CB197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2161" y="2688148"/>
            <a:ext cx="2523510" cy="1809661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="" xmlns:a16="http://schemas.microsoft.com/office/drawing/2014/main" id="{30A240BA-0F7B-0445-17E0-A2FDB0D17FD7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2161" y="619116"/>
            <a:ext cx="2523510" cy="1797732"/>
          </a:xfrm>
          <a:prstGeom prst="rect">
            <a:avLst/>
          </a:prstGeom>
        </p:spPr>
      </p:pic>
      <p:graphicFrame>
        <p:nvGraphicFramePr>
          <p:cNvPr id="8" name="オブジェクト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72903680"/>
              </p:ext>
            </p:extLst>
          </p:nvPr>
        </p:nvGraphicFramePr>
        <p:xfrm>
          <a:off x="1891767" y="4492092"/>
          <a:ext cx="2403104" cy="28372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Prism 8" r:id="rId6" imgW="2357088" imgH="2988198" progId="Prism8.Document">
                  <p:embed/>
                </p:oleObj>
              </mc:Choice>
              <mc:Fallback>
                <p:oleObj name="Prism 8" r:id="rId6" imgW="2357088" imgH="298819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891767" y="4492092"/>
                        <a:ext cx="2403104" cy="28372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テキスト ボックス 13"/>
          <p:cNvSpPr txBox="1"/>
          <p:nvPr/>
        </p:nvSpPr>
        <p:spPr>
          <a:xfrm>
            <a:off x="1523085" y="5017314"/>
            <a:ext cx="553998" cy="122682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dan-Ⅳ</a:t>
            </a:r>
          </a:p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% Lesion Area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="" xmlns:a16="http://schemas.microsoft.com/office/drawing/2014/main" id="{3959DF36-38F7-717A-3C96-5AB39374103A}"/>
              </a:ext>
            </a:extLst>
          </p:cNvPr>
          <p:cNvSpPr txBox="1"/>
          <p:nvPr/>
        </p:nvSpPr>
        <p:spPr>
          <a:xfrm>
            <a:off x="3147175" y="2360572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="" xmlns:a16="http://schemas.microsoft.com/office/drawing/2014/main" id="{52F1A8E9-4C22-E1B1-A441-88F8836D1E03}"/>
              </a:ext>
            </a:extLst>
          </p:cNvPr>
          <p:cNvSpPr txBox="1"/>
          <p:nvPr/>
        </p:nvSpPr>
        <p:spPr>
          <a:xfrm>
            <a:off x="216351" y="2360192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="" xmlns:a16="http://schemas.microsoft.com/office/drawing/2014/main" id="{710AF5B8-9324-5CA7-215A-68880C1B09C6}"/>
              </a:ext>
            </a:extLst>
          </p:cNvPr>
          <p:cNvSpPr txBox="1"/>
          <p:nvPr/>
        </p:nvSpPr>
        <p:spPr>
          <a:xfrm>
            <a:off x="3996025" y="351250"/>
            <a:ext cx="11256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-DM</a:t>
            </a:r>
            <a:r>
              <a:rPr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i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="" xmlns:a16="http://schemas.microsoft.com/office/drawing/2014/main" id="{70C8D59A-49AA-E733-21F7-F6AA2FAFB04D}"/>
              </a:ext>
            </a:extLst>
          </p:cNvPr>
          <p:cNvSpPr txBox="1"/>
          <p:nvPr/>
        </p:nvSpPr>
        <p:spPr>
          <a:xfrm>
            <a:off x="1206213" y="2439521"/>
            <a:ext cx="8611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="" xmlns:a16="http://schemas.microsoft.com/office/drawing/2014/main" id="{3FC9BA67-9F47-BA1E-2D9F-A6ED08909712}"/>
              </a:ext>
            </a:extLst>
          </p:cNvPr>
          <p:cNvSpPr txBox="1"/>
          <p:nvPr/>
        </p:nvSpPr>
        <p:spPr>
          <a:xfrm>
            <a:off x="1586307" y="4497809"/>
            <a:ext cx="45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図 1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75640" y="2698746"/>
            <a:ext cx="2528837" cy="1810464"/>
          </a:xfrm>
          <a:prstGeom prst="rect">
            <a:avLst/>
          </a:prstGeom>
        </p:spPr>
      </p:pic>
      <p:pic>
        <p:nvPicPr>
          <p:cNvPr id="13" name="図 1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70250" y="611775"/>
            <a:ext cx="2533061" cy="1781323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="" xmlns:a16="http://schemas.microsoft.com/office/drawing/2014/main" id="{BEE2D02A-970B-BAF1-E085-4FE62B7B8135}"/>
              </a:ext>
            </a:extLst>
          </p:cNvPr>
          <p:cNvSpPr txBox="1"/>
          <p:nvPr/>
        </p:nvSpPr>
        <p:spPr>
          <a:xfrm>
            <a:off x="3537055" y="32327"/>
            <a:ext cx="23647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="" xmlns:a16="http://schemas.microsoft.com/office/drawing/2014/main" id="{7BE36DC7-D439-2956-921B-8735F9FD9FC4}"/>
              </a:ext>
            </a:extLst>
          </p:cNvPr>
          <p:cNvSpPr txBox="1"/>
          <p:nvPr/>
        </p:nvSpPr>
        <p:spPr>
          <a:xfrm>
            <a:off x="73391" y="7218698"/>
            <a:ext cx="603985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: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Atherosclerotic lesion in aortic arch in non-DM control (A), non-DM spironolactone (B), DM control (C) and DM spironolactone (D). (E) There was no significant decrease in plaque area in the spironolactone group compared to the control group (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= 4-8).</a:t>
            </a:r>
          </a:p>
          <a:p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8087744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85</TotalTime>
  <Words>199</Words>
  <Application>Microsoft Office PowerPoint</Application>
  <PresentationFormat>ユーザー設定</PresentationFormat>
  <Paragraphs>22</Paragraphs>
  <Slides>2</Slides>
  <Notes>1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10" baseType="lpstr">
      <vt:lpstr>ＭＳ Ｐゴシック</vt:lpstr>
      <vt:lpstr>ＭＳ 明朝</vt:lpstr>
      <vt:lpstr>Arial</vt:lpstr>
      <vt:lpstr>Calibri</vt:lpstr>
      <vt:lpstr>Calibri Light</vt:lpstr>
      <vt:lpstr>Times New Roman</vt:lpstr>
      <vt:lpstr>Office テーマ</vt:lpstr>
      <vt:lpstr>Prism 8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unpei</dc:creator>
  <cp:lastModifiedBy>Microsoft アカウント</cp:lastModifiedBy>
  <cp:revision>610</cp:revision>
  <cp:lastPrinted>2022-06-09T07:51:59Z</cp:lastPrinted>
  <dcterms:created xsi:type="dcterms:W3CDTF">2020-05-09T01:31:02Z</dcterms:created>
  <dcterms:modified xsi:type="dcterms:W3CDTF">2025-02-19T08:18:38Z</dcterms:modified>
</cp:coreProperties>
</file>